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 varScale="1">
        <p:scale>
          <a:sx n="42" d="100"/>
          <a:sy n="42" d="100"/>
        </p:scale>
        <p:origin x="2544" y="66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56875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8267" y="6223399"/>
            <a:ext cx="575418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| Predictive metabolomics using metabolic fingerprints of Atacama soil samples. a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least squares discriminant analysis using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nosissim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features (5 features,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FDR correction).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least squares regression (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alyses using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imbricata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features (52 features,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using 50 permuted datasets (52 features). All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s were performed 50 times. Tukey’s tests were performed to compare predictions between elevation level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. In the boxplot, the diamond represents the mean while the solid dark line represents the median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7"/>
            <a:ext cx="5760000" cy="569053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0141D0E8-AE10-F091-A389-A1CC2D5588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739" y="590930"/>
            <a:ext cx="2808000" cy="2717515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90D5A9E1-1DC3-9E15-CB60-1563F803B4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4569" y="579196"/>
            <a:ext cx="2808000" cy="2729249"/>
          </a:xfrm>
          <a:prstGeom prst="rect">
            <a:avLst/>
          </a:prstGeom>
        </p:spPr>
      </p:pic>
      <p:sp>
        <p:nvSpPr>
          <p:cNvPr id="26" name="ZoneTexte 25">
            <a:extLst>
              <a:ext uri="{FF2B5EF4-FFF2-40B4-BE49-F238E27FC236}">
                <a16:creationId xmlns:a16="http://schemas.microsoft.com/office/drawing/2014/main" id="{94665007-5D30-FCB1-BB90-D764D0456AD2}"/>
              </a:ext>
            </a:extLst>
          </p:cNvPr>
          <p:cNvSpPr txBox="1"/>
          <p:nvPr/>
        </p:nvSpPr>
        <p:spPr>
          <a:xfrm>
            <a:off x="548909" y="52548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1A36F7A-F81F-DD06-9F7C-6F5EA83A44F5}"/>
              </a:ext>
            </a:extLst>
          </p:cNvPr>
          <p:cNvSpPr txBox="1"/>
          <p:nvPr/>
        </p:nvSpPr>
        <p:spPr>
          <a:xfrm>
            <a:off x="3297072" y="52548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pic>
        <p:nvPicPr>
          <p:cNvPr id="3" name="Image 2" descr="Une image contenant texte, capture d’écran, diagramme, Rectangle&#10;&#10;Description générée automatiquement">
            <a:extLst>
              <a:ext uri="{FF2B5EF4-FFF2-40B4-BE49-F238E27FC236}">
                <a16:creationId xmlns:a16="http://schemas.microsoft.com/office/drawing/2014/main" id="{7F0DAC09-7AAD-8C0D-BBAA-C1096062289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935" y="3433087"/>
            <a:ext cx="1453057" cy="273600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CFA89403-A00A-A289-6B35-82C511C560EC}"/>
              </a:ext>
            </a:extLst>
          </p:cNvPr>
          <p:cNvSpPr txBox="1"/>
          <p:nvPr/>
        </p:nvSpPr>
        <p:spPr>
          <a:xfrm>
            <a:off x="548909" y="326459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412113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118</Words>
  <Application>Microsoft Office PowerPoint</Application>
  <PresentationFormat>Format A4 (210 x 297 mm)</PresentationFormat>
  <Paragraphs>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9:18Z</dcterms:modified>
</cp:coreProperties>
</file>